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7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F6D05E-AE9F-40E4-9887-D3111E51F5AA}" type="datetimeFigureOut">
              <a:rPr lang="en-GB" smtClean="0"/>
              <a:t>29/07/2019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2205A0-5C84-4A5C-BD57-383F3C18A037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5104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D288A-0040-4D80-A67E-6BBA4A55CDDF}" type="datetimeFigureOut">
              <a:rPr lang="en-GB" smtClean="0"/>
              <a:t>29/07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89D75-EA66-4D22-B78D-9DCCD53AB66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1165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D288A-0040-4D80-A67E-6BBA4A55CDDF}" type="datetimeFigureOut">
              <a:rPr lang="en-GB" smtClean="0"/>
              <a:t>29/07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89D75-EA66-4D22-B78D-9DCCD53AB66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01403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D288A-0040-4D80-A67E-6BBA4A55CDDF}" type="datetimeFigureOut">
              <a:rPr lang="en-GB" smtClean="0"/>
              <a:t>29/07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89D75-EA66-4D22-B78D-9DCCD53AB66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7590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D288A-0040-4D80-A67E-6BBA4A55CDDF}" type="datetimeFigureOut">
              <a:rPr lang="en-GB" smtClean="0"/>
              <a:t>29/07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89D75-EA66-4D22-B78D-9DCCD53AB66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0646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D288A-0040-4D80-A67E-6BBA4A55CDDF}" type="datetimeFigureOut">
              <a:rPr lang="en-GB" smtClean="0"/>
              <a:t>29/07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89D75-EA66-4D22-B78D-9DCCD53AB66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7681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D288A-0040-4D80-A67E-6BBA4A55CDDF}" type="datetimeFigureOut">
              <a:rPr lang="en-GB" smtClean="0"/>
              <a:t>29/07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89D75-EA66-4D22-B78D-9DCCD53AB66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02302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D288A-0040-4D80-A67E-6BBA4A55CDDF}" type="datetimeFigureOut">
              <a:rPr lang="en-GB" smtClean="0"/>
              <a:t>29/07/2019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89D75-EA66-4D22-B78D-9DCCD53AB66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5764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D288A-0040-4D80-A67E-6BBA4A55CDDF}" type="datetimeFigureOut">
              <a:rPr lang="en-GB" smtClean="0"/>
              <a:t>29/07/2019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89D75-EA66-4D22-B78D-9DCCD53AB66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2778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D288A-0040-4D80-A67E-6BBA4A55CDDF}" type="datetimeFigureOut">
              <a:rPr lang="en-GB" smtClean="0"/>
              <a:t>29/07/2019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89D75-EA66-4D22-B78D-9DCCD53AB66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21637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D288A-0040-4D80-A67E-6BBA4A55CDDF}" type="datetimeFigureOut">
              <a:rPr lang="en-GB" smtClean="0"/>
              <a:t>29/07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89D75-EA66-4D22-B78D-9DCCD53AB66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2148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D288A-0040-4D80-A67E-6BBA4A55CDDF}" type="datetimeFigureOut">
              <a:rPr lang="en-GB" smtClean="0"/>
              <a:t>29/07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89D75-EA66-4D22-B78D-9DCCD53AB66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35169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9D288A-0040-4D80-A67E-6BBA4A55CDDF}" type="datetimeFigureOut">
              <a:rPr lang="en-GB" smtClean="0"/>
              <a:t>29/07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789D75-EA66-4D22-B78D-9DCCD53AB66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41766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12"/>
          <p:cNvSpPr txBox="1">
            <a:spLocks noChangeArrowheads="1"/>
          </p:cNvSpPr>
          <p:nvPr/>
        </p:nvSpPr>
        <p:spPr bwMode="auto">
          <a:xfrm>
            <a:off x="6241387" y="2140427"/>
            <a:ext cx="5751512" cy="12003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fr-FR" altLang="fr-FR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kumimoji="0" lang="fr-FR" altLang="fr-FR" sz="12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alt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kumimoji="0" lang="fr-FR" altLang="fr-FR" sz="12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gure 1: adipocyte-</a:t>
            </a:r>
            <a:r>
              <a:rPr kumimoji="0" lang="fr-FR" altLang="fr-FR" sz="120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onditioned</a:t>
            </a:r>
            <a:r>
              <a:rPr kumimoji="0" lang="fr-FR" altLang="fr-FR" sz="12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medium </a:t>
            </a:r>
            <a:r>
              <a:rPr kumimoji="0" lang="fr-FR" altLang="fr-FR" sz="120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oes</a:t>
            </a:r>
            <a:r>
              <a:rPr kumimoji="0" lang="fr-FR" altLang="fr-FR" sz="12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not </a:t>
            </a:r>
            <a:r>
              <a:rPr kumimoji="0" lang="fr-FR" altLang="fr-FR" sz="120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imulate</a:t>
            </a:r>
            <a:r>
              <a:rPr kumimoji="0" lang="fr-FR" altLang="fr-FR" sz="12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fr-FR" altLang="fr-FR" sz="120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kumimoji="0" lang="fr-FR" altLang="fr-FR" sz="12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fr-FR" altLang="fr-FR" sz="120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oliferation</a:t>
            </a:r>
            <a:r>
              <a:rPr kumimoji="0" lang="fr-FR" altLang="fr-FR" sz="1200" b="1" i="0" u="none" strike="noStrike" cap="none" normalizeH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kumimoji="0" lang="fr-FR" altLang="fr-FR" sz="12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T-474 </a:t>
            </a:r>
            <a:r>
              <a:rPr kumimoji="0" lang="fr-FR" altLang="fr-FR" sz="120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kumimoji="0" lang="fr-FR" altLang="fr-FR" sz="12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fr-FR" altLang="fr-FR" sz="120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kumimoji="0" lang="fr-FR" altLang="fr-FR" sz="12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fr-FR" altLang="fr-FR" sz="120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ained</a:t>
            </a:r>
            <a:r>
              <a:rPr kumimoji="0" lang="fr-FR" altLang="fr-FR" sz="12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r not (NL) </a:t>
            </a:r>
            <a:r>
              <a:rPr kumimoji="0" lang="fr-FR" altLang="fr-FR" sz="120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kumimoji="0" lang="fr-FR" altLang="fr-FR" sz="12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CFSE and </a:t>
            </a:r>
            <a:r>
              <a:rPr kumimoji="0" lang="fr-FR" altLang="fr-FR" sz="120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ncubated</a:t>
            </a:r>
            <a:r>
              <a:rPr kumimoji="0" lang="fr-FR" altLang="fr-FR" sz="12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in control medium or in adipocyte-</a:t>
            </a:r>
            <a:r>
              <a:rPr kumimoji="0" lang="fr-FR" altLang="fr-FR" sz="120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onditioned</a:t>
            </a:r>
            <a:r>
              <a:rPr kumimoji="0" lang="fr-FR" altLang="fr-FR" sz="12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medium. The </a:t>
            </a:r>
            <a:r>
              <a:rPr kumimoji="0" lang="fr-FR" altLang="fr-FR" sz="120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ntensity</a:t>
            </a:r>
            <a:r>
              <a:rPr kumimoji="0" lang="fr-FR" altLang="fr-FR" sz="12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f fluorescence </a:t>
            </a:r>
            <a:r>
              <a:rPr kumimoji="0" lang="fr-FR" altLang="fr-FR" sz="120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leased</a:t>
            </a:r>
            <a:r>
              <a:rPr kumimoji="0" lang="fr-FR" altLang="fr-FR" sz="12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by the </a:t>
            </a:r>
            <a:r>
              <a:rPr kumimoji="0" lang="fr-FR" altLang="fr-FR" sz="120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ained</a:t>
            </a:r>
            <a:r>
              <a:rPr kumimoji="0" lang="fr-FR" altLang="fr-FR" sz="12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fr-FR" altLang="fr-FR" sz="120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r>
              <a:rPr kumimoji="0" lang="fr-FR" altLang="fr-FR" sz="12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fr-FR" altLang="fr-FR" sz="120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kumimoji="0" lang="fr-FR" altLang="fr-FR" sz="12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fr-FR" altLang="fr-FR" sz="120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kumimoji="0" lang="fr-FR" altLang="fr-FR" sz="12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fr-FR" altLang="fr-FR" sz="120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ollowed</a:t>
            </a:r>
            <a:r>
              <a:rPr kumimoji="0" lang="fr-FR" altLang="fr-FR" sz="12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by flow </a:t>
            </a:r>
            <a:r>
              <a:rPr kumimoji="0" lang="fr-FR" altLang="fr-FR" sz="120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kumimoji="0" lang="fr-FR" altLang="fr-FR" sz="12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for 8 </a:t>
            </a:r>
            <a:r>
              <a:rPr kumimoji="0" lang="fr-FR" altLang="fr-FR" sz="120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r>
              <a:rPr lang="fr-FR" alt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alt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</a:t>
            </a:r>
            <a:r>
              <a:rPr lang="fr-FR" alt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alt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related</a:t>
            </a:r>
            <a:r>
              <a:rPr lang="fr-FR" alt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alt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nsity</a:t>
            </a:r>
            <a:r>
              <a:rPr lang="fr-FR" alt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fluorescence </a:t>
            </a:r>
            <a:r>
              <a:rPr lang="fr-FR" alt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alt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 </a:t>
            </a:r>
            <a:r>
              <a:rPr lang="fr-FR" alt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</a:t>
            </a:r>
            <a:r>
              <a:rPr lang="fr-FR" alt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alt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fr-FR" alt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alt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belled</a:t>
            </a:r>
            <a:r>
              <a:rPr lang="fr-FR" alt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alt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alt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FSE. The </a:t>
            </a:r>
            <a:r>
              <a:rPr lang="fr-FR" alt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gative</a:t>
            </a:r>
            <a:r>
              <a:rPr lang="fr-FR" alt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ntrol </a:t>
            </a:r>
            <a:r>
              <a:rPr lang="fr-FR" alt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fr-FR" alt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alt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e</a:t>
            </a:r>
            <a:r>
              <a:rPr lang="fr-FR" alt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alt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r>
              <a:rPr lang="fr-FR" alt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alt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fr-FR" alt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alt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labelled</a:t>
            </a:r>
            <a:r>
              <a:rPr lang="fr-FR" alt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alt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alt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FSE (UL).</a:t>
            </a:r>
            <a:endParaRPr kumimoji="0" lang="fr-FR" altLang="fr-FR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Objet 5"/>
          <p:cNvGraphicFramePr>
            <a:graphicFrameLocks noChangeAspect="1"/>
          </p:cNvGraphicFramePr>
          <p:nvPr>
            <p:extLst/>
          </p:nvPr>
        </p:nvGraphicFramePr>
        <p:xfrm>
          <a:off x="624840" y="1426936"/>
          <a:ext cx="4608513" cy="2627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9" name="Prism Project" r:id="rId3" imgW="4608000" imgH="2628000" progId="Prism5.Document">
                  <p:embed/>
                </p:oleObj>
              </mc:Choice>
              <mc:Fallback>
                <p:oleObj name="Prism Project" r:id="rId3" imgW="4608000" imgH="2628000" progId="Prism5.Document">
                  <p:embed/>
                  <p:pic>
                    <p:nvPicPr>
                      <p:cNvPr id="6" name="Objet 5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24840" y="1426936"/>
                        <a:ext cx="4608513" cy="2627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4054141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81</Words>
  <Application>Microsoft Office PowerPoint</Application>
  <PresentationFormat>Grand écran</PresentationFormat>
  <Paragraphs>1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ème Office</vt:lpstr>
      <vt:lpstr>Prism Project</vt:lpstr>
      <vt:lpstr>Présentation PowerPoint</vt:lpstr>
    </vt:vector>
  </TitlesOfParts>
  <Company>UCBL - Lyon 1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ONILH LOUISE</dc:creator>
  <cp:lastModifiedBy>CONILH LOUISE</cp:lastModifiedBy>
  <cp:revision>8</cp:revision>
  <dcterms:created xsi:type="dcterms:W3CDTF">2019-07-29T08:09:02Z</dcterms:created>
  <dcterms:modified xsi:type="dcterms:W3CDTF">2019-07-29T08:15:59Z</dcterms:modified>
</cp:coreProperties>
</file>